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76" r:id="rId2"/>
  </p:sldIdLst>
  <p:sldSz cx="6840538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0432FF"/>
    <a:srgbClr val="654B4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3289"/>
    <p:restoredTop sz="94651"/>
  </p:normalViewPr>
  <p:slideViewPr>
    <p:cSldViewPr snapToGrid="0">
      <p:cViewPr varScale="1">
        <p:scale>
          <a:sx n="91" d="100"/>
          <a:sy n="91" d="100"/>
        </p:scale>
        <p:origin x="263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415E46-7790-044A-9762-68807AD201AC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8213" y="1143000"/>
            <a:ext cx="2441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A2C18D-D97C-FE4F-8227-06E7E77C1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0648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FEE7905-AD3B-6121-3142-08BFE7D057E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92E2BCA1-C8F3-1C91-CCDF-61D0FD6D1E8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ECDA9E31-8782-1F25-1B5C-01E8395BB988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76A469F-2DEA-AA04-BEB4-F44349B8C2E8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FA2C18D-D97C-FE4F-8227-06E7E77C1E3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2071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414125"/>
            <a:ext cx="5814457" cy="3008266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538401"/>
            <a:ext cx="5130404" cy="2086184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185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7041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60041"/>
            <a:ext cx="1474991" cy="732264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60041"/>
            <a:ext cx="4339466" cy="732264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365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022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154193"/>
            <a:ext cx="5899964" cy="3594317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5782513"/>
            <a:ext cx="5899964" cy="1890166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>
                    <a:tint val="82000"/>
                  </a:schemeClr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82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82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942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300203"/>
            <a:ext cx="2907229" cy="54824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300203"/>
            <a:ext cx="2907229" cy="54824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081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60043"/>
            <a:ext cx="5899964" cy="167014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118188"/>
            <a:ext cx="2893868" cy="1038091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156278"/>
            <a:ext cx="2893868" cy="46424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118188"/>
            <a:ext cx="2908120" cy="1038091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156278"/>
            <a:ext cx="2908120" cy="46424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424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92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475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76051"/>
            <a:ext cx="2206252" cy="201617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244112"/>
            <a:ext cx="3463022" cy="6140542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592229"/>
            <a:ext cx="2206252" cy="4802425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96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76051"/>
            <a:ext cx="2206252" cy="201617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244112"/>
            <a:ext cx="3463022" cy="6140542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592229"/>
            <a:ext cx="2206252" cy="4802425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534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60043"/>
            <a:ext cx="5899964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300203"/>
            <a:ext cx="5899964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8008709"/>
            <a:ext cx="1539121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8008709"/>
            <a:ext cx="2308682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8008709"/>
            <a:ext cx="1539121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190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798AA14-4971-E0C7-0771-39288216EDC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>
            <a:extLst>
              <a:ext uri="{FF2B5EF4-FFF2-40B4-BE49-F238E27FC236}">
                <a16:creationId xmlns:a16="http://schemas.microsoft.com/office/drawing/2014/main" id="{4F1EB24C-E292-36D4-F22F-D17A818797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8098" y="3582852"/>
            <a:ext cx="2203722" cy="14400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B8B456C0-5068-F253-8200-7D05967C093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86149" y="3551816"/>
            <a:ext cx="2194840" cy="14400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BF8CF537-38D5-21F2-A1A9-2B26E0F332A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80989" y="3509197"/>
            <a:ext cx="2194838" cy="144000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FB8D381A-353A-3290-B976-3D9DBD57F170}"/>
              </a:ext>
            </a:extLst>
          </p:cNvPr>
          <p:cNvSpPr txBox="1"/>
          <p:nvPr/>
        </p:nvSpPr>
        <p:spPr>
          <a:xfrm rot="16200000">
            <a:off x="-306844" y="4103811"/>
            <a:ext cx="8521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D14+ EVs</a:t>
            </a:r>
            <a:endParaRPr lang="en-CA" sz="700" dirty="0">
              <a:solidFill>
                <a:srgbClr val="18191B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4E3DC6F-877B-EE81-2AC7-A5F22C4EB4D8}"/>
              </a:ext>
            </a:extLst>
          </p:cNvPr>
          <p:cNvSpPr txBox="1"/>
          <p:nvPr/>
        </p:nvSpPr>
        <p:spPr>
          <a:xfrm rot="16200000">
            <a:off x="2044406" y="4093207"/>
            <a:ext cx="7470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D19+ EVs</a:t>
            </a:r>
            <a:endParaRPr lang="en-CA" sz="700" dirty="0">
              <a:solidFill>
                <a:srgbClr val="18191B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369EB0B-74E8-B8B9-E857-B945732B8BE5}"/>
              </a:ext>
            </a:extLst>
          </p:cNvPr>
          <p:cNvSpPr txBox="1"/>
          <p:nvPr/>
        </p:nvSpPr>
        <p:spPr>
          <a:xfrm>
            <a:off x="1747759" y="4361568"/>
            <a:ext cx="6286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=-0.4805</a:t>
            </a:r>
          </a:p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=0.1451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E3A5D57-6EE4-DA8A-A8BC-BD256CBB6CF4}"/>
              </a:ext>
            </a:extLst>
          </p:cNvPr>
          <p:cNvSpPr txBox="1"/>
          <p:nvPr/>
        </p:nvSpPr>
        <p:spPr>
          <a:xfrm>
            <a:off x="4019457" y="4555953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=-0.07804</a:t>
            </a:r>
          </a:p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=0.7739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DD02985-D74E-468D-E7D1-F25004F2F74A}"/>
              </a:ext>
            </a:extLst>
          </p:cNvPr>
          <p:cNvSpPr txBox="1"/>
          <p:nvPr/>
        </p:nvSpPr>
        <p:spPr>
          <a:xfrm>
            <a:off x="6117704" y="3674662"/>
            <a:ext cx="6190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=0.3351</a:t>
            </a:r>
          </a:p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=0.3416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F7789D0-9FE1-5FD9-2A0C-5F008303332B}"/>
              </a:ext>
            </a:extLst>
          </p:cNvPr>
          <p:cNvSpPr txBox="1"/>
          <p:nvPr/>
        </p:nvSpPr>
        <p:spPr>
          <a:xfrm rot="16200000">
            <a:off x="4220710" y="4072574"/>
            <a:ext cx="8425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D45+ EVs</a:t>
            </a:r>
            <a:endParaRPr lang="en-CA" sz="700" dirty="0">
              <a:solidFill>
                <a:srgbClr val="18191B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808FAC2-02C5-E7D1-6941-EF1335D24851}"/>
              </a:ext>
            </a:extLst>
          </p:cNvPr>
          <p:cNvSpPr txBox="1"/>
          <p:nvPr/>
        </p:nvSpPr>
        <p:spPr>
          <a:xfrm>
            <a:off x="711348" y="4883122"/>
            <a:ext cx="107405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DSS rate (</a:t>
            </a:r>
            <a:r>
              <a:rPr lang="el-GR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700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year)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4EA80A11-3979-6640-066B-99826551F52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7433" y="513314"/>
            <a:ext cx="5893875" cy="2657238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CE0C3987-EE95-EE57-DACE-43D6A8F73FAB}"/>
              </a:ext>
            </a:extLst>
          </p:cNvPr>
          <p:cNvSpPr txBox="1"/>
          <p:nvPr/>
        </p:nvSpPr>
        <p:spPr>
          <a:xfrm rot="16200000">
            <a:off x="-697062" y="1633462"/>
            <a:ext cx="2194832" cy="2231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5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tio (CD14 or CD19/CD45; CD45/CD9)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ECA2FE8B-33B0-A575-ACEA-396D07BFF29C}"/>
              </a:ext>
            </a:extLst>
          </p:cNvPr>
          <p:cNvSpPr txBox="1"/>
          <p:nvPr/>
        </p:nvSpPr>
        <p:spPr>
          <a:xfrm>
            <a:off x="2951671" y="4873165"/>
            <a:ext cx="9752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DSS rate (</a:t>
            </a:r>
            <a:r>
              <a:rPr lang="el-GR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700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year)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655EAF1-66C9-1EF2-01F8-A5F84291C91A}"/>
              </a:ext>
            </a:extLst>
          </p:cNvPr>
          <p:cNvSpPr txBox="1"/>
          <p:nvPr/>
        </p:nvSpPr>
        <p:spPr>
          <a:xfrm>
            <a:off x="5270840" y="4847732"/>
            <a:ext cx="107405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DSS rate (</a:t>
            </a:r>
            <a:r>
              <a:rPr lang="el-GR" sz="700" b="1" dirty="0">
                <a:solidFill>
                  <a:srgbClr val="18191B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700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year)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480227A-58B0-1A90-4524-E83AD0E50A8A}"/>
              </a:ext>
            </a:extLst>
          </p:cNvPr>
          <p:cNvSpPr txBox="1"/>
          <p:nvPr/>
        </p:nvSpPr>
        <p:spPr>
          <a:xfrm>
            <a:off x="4130" y="194831"/>
            <a:ext cx="3962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32D149B1-3528-4642-89A4-B3416195CF2B}"/>
              </a:ext>
            </a:extLst>
          </p:cNvPr>
          <p:cNvSpPr txBox="1"/>
          <p:nvPr/>
        </p:nvSpPr>
        <p:spPr>
          <a:xfrm>
            <a:off x="33769" y="3202172"/>
            <a:ext cx="3962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A78CAD4-0255-288D-6F27-7E114742908B}"/>
              </a:ext>
            </a:extLst>
          </p:cNvPr>
          <p:cNvSpPr txBox="1"/>
          <p:nvPr/>
        </p:nvSpPr>
        <p:spPr>
          <a:xfrm>
            <a:off x="202242" y="-26588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42A246C-A132-12F3-6174-0DBA8322E9FE}"/>
              </a:ext>
            </a:extLst>
          </p:cNvPr>
          <p:cNvSpPr txBox="1"/>
          <p:nvPr/>
        </p:nvSpPr>
        <p:spPr>
          <a:xfrm>
            <a:off x="960364" y="3379811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 EV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EFCE37F-3922-AD10-300E-BF4BDCAD9087}"/>
              </a:ext>
            </a:extLst>
          </p:cNvPr>
          <p:cNvSpPr txBox="1"/>
          <p:nvPr/>
        </p:nvSpPr>
        <p:spPr>
          <a:xfrm>
            <a:off x="3075705" y="3345816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9 EV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7875AD9-CF17-F294-A41A-B146450729DE}"/>
              </a:ext>
            </a:extLst>
          </p:cNvPr>
          <p:cNvSpPr txBox="1"/>
          <p:nvPr/>
        </p:nvSpPr>
        <p:spPr>
          <a:xfrm>
            <a:off x="5269921" y="3334785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5 EVs</a:t>
            </a:r>
          </a:p>
        </p:txBody>
      </p:sp>
    </p:spTree>
    <p:extLst>
      <p:ext uri="{BB962C8B-B14F-4D97-AF65-F5344CB8AC3E}">
        <p14:creationId xmlns:p14="http://schemas.microsoft.com/office/powerpoint/2010/main" val="4152635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3</TotalTime>
  <Words>75</Words>
  <Application>Microsoft Macintosh PowerPoint</Application>
  <PresentationFormat>Custom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ennifer Leigh Zagrodnik</dc:creator>
  <cp:lastModifiedBy>Moore, Craig S.</cp:lastModifiedBy>
  <cp:revision>27</cp:revision>
  <cp:lastPrinted>2024-10-15T17:54:31Z</cp:lastPrinted>
  <dcterms:created xsi:type="dcterms:W3CDTF">2024-10-10T14:11:55Z</dcterms:created>
  <dcterms:modified xsi:type="dcterms:W3CDTF">2024-12-20T19:18:00Z</dcterms:modified>
</cp:coreProperties>
</file>